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37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 varScale="1">
        <p:scale>
          <a:sx n="80" d="100"/>
          <a:sy n="80" d="100"/>
        </p:scale>
        <p:origin x="682" y="67"/>
      </p:cViewPr>
      <p:guideLst>
        <p:guide orient="horz" pos="2137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ABB83-8F52-4498-BB1B-27CEB8D01A9E}" type="datetimeFigureOut">
              <a:rPr lang="zh-CN" altLang="en-US" smtClean="0"/>
              <a:t>2017/12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E4DC1-3247-4B0B-9741-06551E79FD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445706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ABB83-8F52-4498-BB1B-27CEB8D01A9E}" type="datetimeFigureOut">
              <a:rPr lang="zh-CN" altLang="en-US" smtClean="0"/>
              <a:t>2017/12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E4DC1-3247-4B0B-9741-06551E79FD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97755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ABB83-8F52-4498-BB1B-27CEB8D01A9E}" type="datetimeFigureOut">
              <a:rPr lang="zh-CN" altLang="en-US" smtClean="0"/>
              <a:t>2017/12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E4DC1-3247-4B0B-9741-06551E79FD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78595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ABB83-8F52-4498-BB1B-27CEB8D01A9E}" type="datetimeFigureOut">
              <a:rPr lang="zh-CN" altLang="en-US" smtClean="0"/>
              <a:t>2017/12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E4DC1-3247-4B0B-9741-06551E79FD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85434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ABB83-8F52-4498-BB1B-27CEB8D01A9E}" type="datetimeFigureOut">
              <a:rPr lang="zh-CN" altLang="en-US" smtClean="0"/>
              <a:t>2017/12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E4DC1-3247-4B0B-9741-06551E79FD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747295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ABB83-8F52-4498-BB1B-27CEB8D01A9E}" type="datetimeFigureOut">
              <a:rPr lang="zh-CN" altLang="en-US" smtClean="0"/>
              <a:t>2017/12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E4DC1-3247-4B0B-9741-06551E79FD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35306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ABB83-8F52-4498-BB1B-27CEB8D01A9E}" type="datetimeFigureOut">
              <a:rPr lang="zh-CN" altLang="en-US" smtClean="0"/>
              <a:t>2017/12/1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E4DC1-3247-4B0B-9741-06551E79FD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081288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ABB83-8F52-4498-BB1B-27CEB8D01A9E}" type="datetimeFigureOut">
              <a:rPr lang="zh-CN" altLang="en-US" smtClean="0"/>
              <a:t>2017/12/1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E4DC1-3247-4B0B-9741-06551E79FD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39734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ABB83-8F52-4498-BB1B-27CEB8D01A9E}" type="datetimeFigureOut">
              <a:rPr lang="zh-CN" altLang="en-US" smtClean="0"/>
              <a:t>2017/12/1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E4DC1-3247-4B0B-9741-06551E79FD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37147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ABB83-8F52-4498-BB1B-27CEB8D01A9E}" type="datetimeFigureOut">
              <a:rPr lang="zh-CN" altLang="en-US" smtClean="0"/>
              <a:t>2017/12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E4DC1-3247-4B0B-9741-06551E79FD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76200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ABB83-8F52-4498-BB1B-27CEB8D01A9E}" type="datetimeFigureOut">
              <a:rPr lang="zh-CN" altLang="en-US" smtClean="0"/>
              <a:t>2017/12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E4DC1-3247-4B0B-9741-06551E79FD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5465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DABB83-8F52-4498-BB1B-27CEB8D01A9E}" type="datetimeFigureOut">
              <a:rPr lang="zh-CN" altLang="en-US" smtClean="0"/>
              <a:t>2017/12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9E4DC1-3247-4B0B-9741-06551E79FD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276002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2889797" y="601207"/>
            <a:ext cx="95534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d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6140238" y="601207"/>
            <a:ext cx="95534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4d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9390679" y="601207"/>
            <a:ext cx="95534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1d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866776" y="1628775"/>
            <a:ext cx="9525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am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495300" y="2847975"/>
            <a:ext cx="13239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gRNA2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1066800" y="4457700"/>
            <a:ext cx="978217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3: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matoxylin-eosin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aining for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w 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epithelialization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fter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ald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jury. The paws of each mice treated with or without 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ox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induced dCas9-E BM-MSCs were collected after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ald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jury for 7 to 21days. The complete healing epithelial layer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s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beled with a dotted line.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7" name="图片 26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703" t="18472" r="8360" b="47916"/>
          <a:stretch/>
        </p:blipFill>
        <p:spPr>
          <a:xfrm>
            <a:off x="1914524" y="1266824"/>
            <a:ext cx="9258301" cy="23050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898838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7</TotalTime>
  <Words>51</Words>
  <Application>Microsoft Office PowerPoint</Application>
  <PresentationFormat>宽屏</PresentationFormat>
  <Paragraphs>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j</dc:creator>
  <cp:lastModifiedBy>jun xiao</cp:lastModifiedBy>
  <cp:revision>26</cp:revision>
  <dcterms:created xsi:type="dcterms:W3CDTF">2017-12-18T02:06:04Z</dcterms:created>
  <dcterms:modified xsi:type="dcterms:W3CDTF">2017-12-19T13:53:43Z</dcterms:modified>
</cp:coreProperties>
</file>